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4" d="100"/>
          <a:sy n="64" d="100"/>
        </p:scale>
        <p:origin x="-1800" y="48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42BD5B-324F-478E-B082-FEA654CCCCEF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CEA7E5-61E0-4168-9270-C973CD0E23C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CEA7E5-61E0-4168-9270-C973CD0E23CC}" type="slidenum">
              <a:rPr lang="zh-TW" altLang="en-US" smtClean="0"/>
              <a:t>1</a:t>
            </a:fld>
            <a:endParaRPr lang="zh-TW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D17D5-B456-40A0-B1B8-7AFC36C4298D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26DF1-3712-4057-B178-06B346FBA060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D17D5-B456-40A0-B1B8-7AFC36C4298D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26DF1-3712-4057-B178-06B346FBA060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D17D5-B456-40A0-B1B8-7AFC36C4298D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26DF1-3712-4057-B178-06B346FBA060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D17D5-B456-40A0-B1B8-7AFC36C4298D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26DF1-3712-4057-B178-06B346FBA060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D17D5-B456-40A0-B1B8-7AFC36C4298D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26DF1-3712-4057-B178-06B346FBA060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D17D5-B456-40A0-B1B8-7AFC36C4298D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26DF1-3712-4057-B178-06B346FBA060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D17D5-B456-40A0-B1B8-7AFC36C4298D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26DF1-3712-4057-B178-06B346FBA060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D17D5-B456-40A0-B1B8-7AFC36C4298D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26DF1-3712-4057-B178-06B346FBA060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D17D5-B456-40A0-B1B8-7AFC36C4298D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26DF1-3712-4057-B178-06B346FBA060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D17D5-B456-40A0-B1B8-7AFC36C4298D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26DF1-3712-4057-B178-06B346FBA060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D17D5-B456-40A0-B1B8-7AFC36C4298D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26DF1-3712-4057-B178-06B346FBA060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AD17D5-B456-40A0-B1B8-7AFC36C4298D}" type="datetimeFigureOut">
              <a:rPr lang="zh-TW" altLang="en-US" smtClean="0"/>
              <a:t>2015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126DF1-3712-4057-B178-06B346FBA060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20688" y="0"/>
            <a:ext cx="5589240" cy="78077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文字方塊 4"/>
          <p:cNvSpPr txBox="1"/>
          <p:nvPr/>
        </p:nvSpPr>
        <p:spPr>
          <a:xfrm>
            <a:off x="260648" y="8028384"/>
            <a:ext cx="63192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 Fig. 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uncropped and unadjusted blots of Fig. 3</a:t>
            </a: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) 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rbal formulas; (</a:t>
            </a: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ngle herbs. The antibodies (anti-</a:t>
            </a:r>
            <a:r>
              <a:rPr lang="en-US" altLang="zh-TW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o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MLC, anti- Total-MLC, and anti-</a:t>
            </a:r>
            <a:r>
              <a:rPr lang="el-GR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) used here were shown in the left of the S3 Fig.</a:t>
            </a:r>
            <a:endParaRPr lang="zh-TW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1</Words>
  <Application>Microsoft Office PowerPoint</Application>
  <PresentationFormat>如螢幕大小 (4:3)</PresentationFormat>
  <Paragraphs>2</Paragraphs>
  <Slides>1</Slides>
  <Notes>1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2" baseType="lpstr">
      <vt:lpstr>Office 佈景主題</vt:lpstr>
      <vt:lpstr>投影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投影片 1</dc:title>
  <dc:creator>TB</dc:creator>
  <cp:lastModifiedBy>TB</cp:lastModifiedBy>
  <cp:revision>1</cp:revision>
  <dcterms:created xsi:type="dcterms:W3CDTF">2015-12-07T02:56:22Z</dcterms:created>
  <dcterms:modified xsi:type="dcterms:W3CDTF">2015-12-07T02:57:59Z</dcterms:modified>
</cp:coreProperties>
</file>